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74"/>
  </p:normalViewPr>
  <p:slideViewPr>
    <p:cSldViewPr snapToGrid="0" snapToObjects="1">
      <p:cViewPr varScale="1">
        <p:scale>
          <a:sx n="131" d="100"/>
          <a:sy n="131" d="100"/>
        </p:scale>
        <p:origin x="3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D21BA5-819A-FB48-A1E0-4665A8973FB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8571A615-34C1-9947-A522-6CB434DC409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458040B-3EBB-9642-A27F-9E5575A5E7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D33D5-8D9C-7241-B6A2-F611B7225C35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86C508B-3B2F-334A-BFAC-F55BA57D2C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13B15A9-835F-BD4B-98D2-ADAB604BD7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8BE2F-B3FB-6945-B6EC-81FBBE219C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98302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F2A217A-8D16-F144-9A10-B9026D5352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ACC8C7A-D37A-2746-88B0-4483B12F20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049CC0C-EC2B-1B4B-B492-041EF36977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D33D5-8D9C-7241-B6A2-F611B7225C35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9CAAFB0-A5A1-DB45-9C91-07DF34DA96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6AF10B9-651A-BC4F-864E-688A214732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8BE2F-B3FB-6945-B6EC-81FBBE219C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9768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F3FE0FAF-6C54-1546-AA7D-C86416FFE79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B27AEA52-1557-2D48-951E-38724D6BC5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1606CEB-FCFF-0D47-955B-AEED191E12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D33D5-8D9C-7241-B6A2-F611B7225C35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288829F-D962-224F-9180-BB43E857AE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2E8ECEB-A162-8340-A921-FEA025F3F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8BE2F-B3FB-6945-B6EC-81FBBE219C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7310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E51BF3C-528B-6742-84E8-D0B942AA69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2F87A5C-6F16-0440-88E3-A18BC19A47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1F6A38D-0BF6-2A41-8E8C-7724DDB06A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D33D5-8D9C-7241-B6A2-F611B7225C35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0DD203D-C3F0-1E45-8C56-C3095EAC32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69E011A-C5EA-E14B-99F4-136F1886D4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8BE2F-B3FB-6945-B6EC-81FBBE219C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03862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B703457-DC59-D849-ADDA-95D16D34AE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47028FB-387B-1B4D-98AD-7BBE9C51C1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31F7547-7A24-8E41-A96B-11D9F46F0D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D33D5-8D9C-7241-B6A2-F611B7225C35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89EF935-6A54-0D4E-AE19-B394A918B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9D44EAE-317D-6A49-BCA9-499EC04249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8BE2F-B3FB-6945-B6EC-81FBBE219C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99547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689A2E3-EF7F-AD43-9154-CD4C6DF2E0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6BAB18D0-3312-5A45-84C4-05E69939BF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D59B2D29-BEA7-1341-B28A-B30B6DCA4C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655AE9D-4D64-A046-8F60-5559FE4917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D33D5-8D9C-7241-B6A2-F611B7225C35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9E07B9A-9C30-E84E-9A08-9A43BA7948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A06B354-F511-D24E-A22F-9B2E45B3BA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8BE2F-B3FB-6945-B6EC-81FBBE219C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31806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457DC73-DC65-7A46-9160-92B736A0E2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06D9884-9D0D-764F-9E09-C1F25D1B85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3FE1A371-407E-EB42-926C-A6D936BEE5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AD34C8E5-CE69-0E40-A595-F76DBA5EA0D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139D1907-C9C9-0849-B595-6DDD03AF17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5B64DA7E-13F1-4C4D-8286-C7354B64BF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D33D5-8D9C-7241-B6A2-F611B7225C35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14A8E689-3745-BB4F-9253-CC9513FF41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DE8D8266-9629-2A4E-92CC-6F089E8518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8BE2F-B3FB-6945-B6EC-81FBBE219C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86753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840C4D8-8301-4E48-9E7A-CA0144AE4E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93EE9C80-DDCF-6E4E-ACA0-8F3D66119B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D33D5-8D9C-7241-B6A2-F611B7225C35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40137FD1-741C-4E45-B370-696AC740C9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58363B60-5BFE-F74C-B4AE-A0FB410756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8BE2F-B3FB-6945-B6EC-81FBBE219C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719968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83555F59-4BDB-584E-93EC-4F08BA2B34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D33D5-8D9C-7241-B6A2-F611B7225C35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E9F19F3D-0CAF-8248-9896-B65BC9D735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CC831B76-C46B-9744-B6DA-455D67DDF2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8BE2F-B3FB-6945-B6EC-81FBBE219C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0307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7660004-C142-5540-B155-873721A01D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DCF8944-D291-D04F-B50B-532499D9B1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B63C121-C77D-C549-8728-2CDD3E126E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8D4257D-C309-D946-AE12-9BC3BE8E7B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D33D5-8D9C-7241-B6A2-F611B7225C35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3F9D56C-593C-4E4B-8966-F3EEBF0C27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461346B-6E29-7446-8DD0-F5193EA2CB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8BE2F-B3FB-6945-B6EC-81FBBE219C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087555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A484125-2993-BA47-9E24-5A783816AE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BA9D362D-DC68-D44F-B693-A7388DBDBBD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095856F-82ED-5249-83DE-5AAA94DA82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706E836-5B5E-CA41-AFF4-2704892C61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BD33D5-8D9C-7241-B6A2-F611B7225C35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A85F28A-E80C-544A-B0A4-C1261EEF61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21F5839-1742-7944-92DA-CF363E9A84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68BE2F-B3FB-6945-B6EC-81FBBE219C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14644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EE2AEE48-62DD-F149-A582-12C0901093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F9A1B19-54BD-2B42-B629-8FA8CCA7B6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FD70E3D-1C94-4542-A1A3-C41FA814AB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BD33D5-8D9C-7241-B6A2-F611B7225C35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3F2EDA4-70C6-7C4A-896B-E23222228B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773603F-5592-3846-8BB9-992EEBE334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68BE2F-B3FB-6945-B6EC-81FBBE219C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4448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em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ZoneTexte 33">
            <a:extLst>
              <a:ext uri="{FF2B5EF4-FFF2-40B4-BE49-F238E27FC236}">
                <a16:creationId xmlns:a16="http://schemas.microsoft.com/office/drawing/2014/main" id="{CE1BEBCF-7C17-B442-82E0-BE189B899F24}"/>
              </a:ext>
            </a:extLst>
          </p:cNvPr>
          <p:cNvSpPr txBox="1"/>
          <p:nvPr/>
        </p:nvSpPr>
        <p:spPr>
          <a:xfrm>
            <a:off x="1117600" y="368996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F21959E9-F600-2841-B626-62C52867107F}"/>
              </a:ext>
            </a:extLst>
          </p:cNvPr>
          <p:cNvSpPr txBox="1"/>
          <p:nvPr/>
        </p:nvSpPr>
        <p:spPr>
          <a:xfrm>
            <a:off x="1027260" y="2766717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d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8613AA31-D4C6-C748-9CDC-3FA665F0AE92}"/>
              </a:ext>
            </a:extLst>
          </p:cNvPr>
          <p:cNvSpPr txBox="1"/>
          <p:nvPr/>
        </p:nvSpPr>
        <p:spPr>
          <a:xfrm>
            <a:off x="4531360" y="36899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9C0AF455-E391-9245-8BCE-98CBD5B4EB78}"/>
              </a:ext>
            </a:extLst>
          </p:cNvPr>
          <p:cNvSpPr txBox="1"/>
          <p:nvPr/>
        </p:nvSpPr>
        <p:spPr>
          <a:xfrm>
            <a:off x="7914640" y="368996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c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ACF3935E-5291-414F-9EC5-F942BB8D3B00}"/>
              </a:ext>
            </a:extLst>
          </p:cNvPr>
          <p:cNvSpPr txBox="1"/>
          <p:nvPr/>
        </p:nvSpPr>
        <p:spPr>
          <a:xfrm>
            <a:off x="4531360" y="277109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e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D16E377E-A670-C541-9CAC-698F7584C055}"/>
              </a:ext>
            </a:extLst>
          </p:cNvPr>
          <p:cNvSpPr txBox="1"/>
          <p:nvPr/>
        </p:nvSpPr>
        <p:spPr>
          <a:xfrm>
            <a:off x="7921406" y="2766717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A89D9B53-F2D8-6247-B08E-37E551DC70B1}"/>
              </a:ext>
            </a:extLst>
          </p:cNvPr>
          <p:cNvSpPr/>
          <p:nvPr/>
        </p:nvSpPr>
        <p:spPr>
          <a:xfrm>
            <a:off x="525294" y="5414377"/>
            <a:ext cx="11186807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sz="1000" b="1" dirty="0">
                <a:latin typeface="Times" pitchFamily="2" charset="0"/>
                <a:ea typeface="Times New Roman" panose="02020603050405020304" pitchFamily="18" charset="0"/>
              </a:rPr>
              <a:t>S3 Fig. Effect of the duration of IPTG pre-treatment and of the medium change frequency on Huh7 cells proliferation in response to inducible sh129921-mediated </a:t>
            </a:r>
            <a:r>
              <a:rPr lang="en-GB" sz="1000" b="1" i="1" dirty="0">
                <a:latin typeface="Times" pitchFamily="2" charset="0"/>
                <a:ea typeface="Times New Roman" panose="02020603050405020304" pitchFamily="18" charset="0"/>
              </a:rPr>
              <a:t>MPV17</a:t>
            </a:r>
            <a:r>
              <a:rPr lang="en-GB" sz="1000" b="1" dirty="0">
                <a:latin typeface="Times" pitchFamily="2" charset="0"/>
                <a:ea typeface="Times New Roman" panose="02020603050405020304" pitchFamily="18" charset="0"/>
              </a:rPr>
              <a:t> knockdown. </a:t>
            </a:r>
            <a:r>
              <a:rPr lang="en-GB" sz="1000" dirty="0">
                <a:latin typeface="Times" pitchFamily="2" charset="0"/>
                <a:ea typeface="Times New Roman" panose="02020603050405020304" pitchFamily="18" charset="0"/>
              </a:rPr>
              <a:t>Cells were transduced, or not (Unt), with inducible sh129921 lentiviral vectors and selected for 6 days with puromycin (2.5 </a:t>
            </a:r>
            <a:r>
              <a:rPr lang="en-GB" sz="1000" dirty="0">
                <a:latin typeface="Times" pitchFamily="2" charset="0"/>
                <a:ea typeface="Times New Roman" panose="02020603050405020304" pitchFamily="18" charset="0"/>
                <a:sym typeface="Symbol" pitchFamily="2" charset="2"/>
              </a:rPr>
              <a:t></a:t>
            </a:r>
            <a:r>
              <a:rPr lang="en-GB" sz="1000" dirty="0">
                <a:latin typeface="Times" pitchFamily="2" charset="0"/>
                <a:ea typeface="Times New Roman" panose="02020603050405020304" pitchFamily="18" charset="0"/>
              </a:rPr>
              <a:t>g/mL). Cells were then incubated for 14 days in the presence of 0.1 mM of IPTG to induce </a:t>
            </a:r>
            <a:r>
              <a:rPr lang="en-GB" sz="1000" i="1" dirty="0">
                <a:latin typeface="Times" pitchFamily="2" charset="0"/>
                <a:ea typeface="Times New Roman" panose="02020603050405020304" pitchFamily="18" charset="0"/>
              </a:rPr>
              <a:t>MPV17</a:t>
            </a:r>
            <a:r>
              <a:rPr lang="en-GB" sz="1000" dirty="0">
                <a:latin typeface="Times" pitchFamily="2" charset="0"/>
                <a:ea typeface="Times New Roman" panose="02020603050405020304" pitchFamily="18" charset="0"/>
              </a:rPr>
              <a:t> silencing and culture medium was changed daily (a, b, c) or every 2 days (c, d, e). Cells were seeded at 8×10</a:t>
            </a:r>
            <a:r>
              <a:rPr lang="en-GB" sz="1000" baseline="30000" dirty="0">
                <a:latin typeface="Times" pitchFamily="2" charset="0"/>
                <a:ea typeface="Times New Roman" panose="02020603050405020304" pitchFamily="18" charset="0"/>
              </a:rPr>
              <a:t>3</a:t>
            </a:r>
            <a:r>
              <a:rPr lang="en-GB" sz="1000" dirty="0">
                <a:latin typeface="Times" pitchFamily="2" charset="0"/>
                <a:ea typeface="Times New Roman" panose="02020603050405020304" pitchFamily="18" charset="0"/>
              </a:rPr>
              <a:t> cells/cm</a:t>
            </a:r>
            <a:r>
              <a:rPr lang="en-GB" sz="1000" baseline="30000" dirty="0">
                <a:latin typeface="Times" pitchFamily="2" charset="0"/>
                <a:ea typeface="Times New Roman" panose="02020603050405020304" pitchFamily="18" charset="0"/>
              </a:rPr>
              <a:t>2</a:t>
            </a:r>
            <a:r>
              <a:rPr lang="en-GB" sz="1000" dirty="0">
                <a:latin typeface="Times" pitchFamily="2" charset="0"/>
                <a:ea typeface="Times New Roman" panose="02020603050405020304" pitchFamily="18" charset="0"/>
              </a:rPr>
              <a:t> and grown for 4 days in presence of IPTG in the same conditions. MPV17 protein abundance was assessed by western blot analysis (a, d) and quantified with Image J software (b, e). Proliferation was then assessed by manual counting to calculate the doubling time (c, f). </a:t>
            </a:r>
            <a:r>
              <a:rPr lang="en-GB" sz="1000" dirty="0">
                <a:latin typeface="Times" pitchFamily="2" charset="0"/>
                <a:cs typeface="Times New Roman" panose="02020603050405020304" pitchFamily="18" charset="0"/>
              </a:rPr>
              <a:t>Full blots are presented in S6 Fig</a:t>
            </a:r>
            <a:r>
              <a:rPr lang="en-GB" sz="1000" dirty="0">
                <a:solidFill>
                  <a:srgbClr val="FF0000"/>
                </a:solidFill>
                <a:latin typeface="Times" pitchFamily="2" charset="0"/>
                <a:cs typeface="Times New Roman" panose="02020603050405020304" pitchFamily="18" charset="0"/>
              </a:rPr>
              <a:t>. </a:t>
            </a:r>
            <a:r>
              <a:rPr lang="en-GB" sz="1000" dirty="0">
                <a:latin typeface="Times" pitchFamily="2" charset="0"/>
                <a:cs typeface="Times New Roman" panose="02020603050405020304" pitchFamily="18" charset="0"/>
              </a:rPr>
              <a:t>D</a:t>
            </a:r>
            <a:r>
              <a:rPr lang="en-GB" sz="1000" dirty="0">
                <a:latin typeface="Times" pitchFamily="2" charset="0"/>
              </a:rPr>
              <a:t>ata are presented as mean ± S.E.M of 3 independent biological replicates. P values were calculated with the one-tailed Mann-Whitney Test (</a:t>
            </a:r>
            <a:r>
              <a:rPr lang="en-US" sz="1000" dirty="0">
                <a:latin typeface="Times" pitchFamily="2" charset="0"/>
              </a:rPr>
              <a:t>⍺</a:t>
            </a:r>
            <a:r>
              <a:rPr lang="en-GB" sz="1000" dirty="0">
                <a:latin typeface="Times" pitchFamily="2" charset="0"/>
              </a:rPr>
              <a:t> = 5 %; NS; *: p&lt;0.05; **: p&lt;0.01; ***: p&lt;0.001)</a:t>
            </a:r>
            <a:r>
              <a:rPr lang="fr-BE" sz="1000" dirty="0">
                <a:latin typeface="Times" pitchFamily="2" charset="0"/>
              </a:rPr>
              <a:t>.</a:t>
            </a:r>
            <a:endParaRPr lang="fr-BE" sz="1000" dirty="0">
              <a:latin typeface="Times" pitchFamily="2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endParaRPr lang="fr-BE" sz="1000" dirty="0">
              <a:effectLst/>
              <a:latin typeface="Times" pitchFamily="2" charset="0"/>
              <a:ea typeface="Times New Roman" panose="02020603050405020304" pitchFamily="18" charset="0"/>
            </a:endParaRPr>
          </a:p>
        </p:txBody>
      </p:sp>
      <p:pic>
        <p:nvPicPr>
          <p:cNvPr id="47" name="Image 46">
            <a:extLst>
              <a:ext uri="{FF2B5EF4-FFF2-40B4-BE49-F238E27FC236}">
                <a16:creationId xmlns:a16="http://schemas.microsoft.com/office/drawing/2014/main" id="{0F27500D-8F0D-2D46-8E6E-2BD905C718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42182" y="449155"/>
            <a:ext cx="2183896" cy="1848771"/>
          </a:xfrm>
          <a:prstGeom prst="rect">
            <a:avLst/>
          </a:prstGeom>
        </p:spPr>
      </p:pic>
      <p:pic>
        <p:nvPicPr>
          <p:cNvPr id="53" name="Image 52">
            <a:extLst>
              <a:ext uri="{FF2B5EF4-FFF2-40B4-BE49-F238E27FC236}">
                <a16:creationId xmlns:a16="http://schemas.microsoft.com/office/drawing/2014/main" id="{A961ECBD-A004-6A40-8739-AAF2C6CB4F8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88284" y="2938759"/>
            <a:ext cx="2196096" cy="1834785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1778B5A3-B0C1-F642-A596-D05865E3080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48217" y="3016656"/>
            <a:ext cx="3280831" cy="2256133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C21497B8-D273-F94E-8EC1-35E2BBCF3A3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83688" y="693326"/>
            <a:ext cx="3061651" cy="2105410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55E4C2E2-E2D3-7F4A-9199-E8E3B6B49D9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394492" y="3016655"/>
            <a:ext cx="3275031" cy="2256133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32581BBA-9723-8D44-B273-6C1D9FD5F0C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413948" y="693326"/>
            <a:ext cx="3077943" cy="21441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659673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2</TotalTime>
  <Words>226</Words>
  <Application>Microsoft Macintosh PowerPoint</Application>
  <PresentationFormat>Grand écran</PresentationFormat>
  <Paragraphs>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6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Times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Microsoft Office User</cp:lastModifiedBy>
  <cp:revision>30</cp:revision>
  <cp:lastPrinted>2019-12-11T07:55:12Z</cp:lastPrinted>
  <dcterms:created xsi:type="dcterms:W3CDTF">2019-03-06T14:56:42Z</dcterms:created>
  <dcterms:modified xsi:type="dcterms:W3CDTF">2020-02-20T13:29:17Z</dcterms:modified>
</cp:coreProperties>
</file>